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259E0A3-322C-4A8D-8799-02116CC3B50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3FA175F-67F2-46AF-87B0-A508B2A401A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46A45-EE68-44E1-B1C3-EDA35B7BEB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38D7C-6138-4910-82C1-3E0248DD25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84EA8-6250-4612-9B5A-E575123C40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80D62-A9D7-421C-A3C6-7AA4B210EC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3290F-FD20-4BF0-B0B0-2356CB929B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B6A9F-B6ED-41E9-BD13-471029DC3B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40FC5-0FA7-43ED-B17B-A18627AB2A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568C0-359B-41D3-9898-BDD9105170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DF259-4EF5-4266-9E87-CFB9FAF631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54D20-1F79-4BD6-BE2D-86BB4A5B84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AC3E3-D50A-4BF3-AD4A-6A2B20AF1A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9CE63-F354-4CE2-AE40-6BBC331F5E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91CF346-78EE-4597-B251-70BA59B7DB2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825480" y="0"/>
            <a:ext cx="8318520" cy="6858000"/>
            <a:chOff x="825480" y="0"/>
            <a:chExt cx="8318520" cy="6858000"/>
          </a:xfrm>
        </p:grpSpPr>
        <p:grpSp>
          <p:nvGrpSpPr>
            <p:cNvPr id="49" name="Group 1"/>
            <p:cNvGrpSpPr/>
            <p:nvPr/>
          </p:nvGrpSpPr>
          <p:grpSpPr>
            <a:xfrm>
              <a:off x="825480" y="0"/>
              <a:ext cx="6573600" cy="6858000"/>
              <a:chOff x="825480" y="0"/>
              <a:chExt cx="6573600" cy="6858000"/>
            </a:xfrm>
          </p:grpSpPr>
          <p:pic>
            <p:nvPicPr>
              <p:cNvPr id="50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825480" y="0"/>
                <a:ext cx="6573600" cy="685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TextBox 12"/>
              <p:cNvSpPr/>
              <p:nvPr/>
            </p:nvSpPr>
            <p:spPr>
              <a:xfrm>
                <a:off x="1706760" y="1846080"/>
                <a:ext cx="385812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603 reaction with methylpropen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12"/>
              <p:cNvSpPr/>
              <p:nvPr/>
            </p:nvSpPr>
            <p:spPr>
              <a:xfrm>
                <a:off x="1706760" y="5240520"/>
                <a:ext cx="391860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LLSY(3-tBu)FGTPT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12"/>
              <p:cNvSpPr/>
              <p:nvPr/>
            </p:nvSpPr>
            <p:spPr>
              <a:xfrm>
                <a:off x="1706760" y="3552840"/>
                <a:ext cx="3813840" cy="33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603 reaction with Boc</a:t>
                </a:r>
                <a:r>
                  <a:rPr b="1" lang="en-GB" sz="1400" spc="-1" strike="noStrike" baseline="-25000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O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2"/>
              <p:cNvSpPr/>
              <p:nvPr/>
            </p:nvSpPr>
            <p:spPr>
              <a:xfrm>
                <a:off x="1706760" y="209520"/>
                <a:ext cx="384228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Active fraction (F8)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5" name="TextBox 10"/>
            <p:cNvSpPr/>
            <p:nvPr/>
          </p:nvSpPr>
          <p:spPr>
            <a:xfrm>
              <a:off x="7431840" y="6140880"/>
              <a:ext cx="1712160" cy="54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pplementary Figure 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13T11:44:58Z</dcterms:created>
  <dc:creator>Information Services</dc:creator>
  <dc:description/>
  <dc:language>en-US</dc:language>
  <cp:lastModifiedBy>Information Services</cp:lastModifiedBy>
  <dcterms:modified xsi:type="dcterms:W3CDTF">2014-09-30T15:13:18Z</dcterms:modified>
  <cp:revision>168</cp:revision>
  <dc:subject/>
  <dc:title>PowerPoint Presentation</dc:title>
</cp:coreProperties>
</file>